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9144000" cy="6858000"/>
  <p:notesSz cx="7005638" cy="929163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87E80B-565C-4AC1-BF08-357E0B39F2A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A4055F-10E8-4046-B5B3-36AB93AFBE6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1BB159-4385-4C39-905F-D623374C4C6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C89BC8-70C6-4EC1-9119-AA92CDB726E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2E7547-ADD8-4D47-9174-A2FCF6055F9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645F49-7F3A-406C-BC5F-19FA21B2A4C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FEFA17-1E1A-4F3F-B647-A098B13BBE9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23659B-522E-4C33-B3E9-7039695BF50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6FD545-1B80-4798-9872-1DD7E43F38B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F3F4D6-B263-4538-953F-DEF2095F566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EFE715-EAAE-4216-864A-0A3CC0B7BF7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2C4DCA-8B03-437C-A3DE-DE1FD959E25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I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663F6C7-808F-41E3-A3AB-22F912CABFCB}" type="slidenum">
              <a:rPr b="0" lang="en-IN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Chart 3" descr=""/>
          <p:cNvPicPr/>
          <p:nvPr/>
        </p:nvPicPr>
        <p:blipFill>
          <a:blip r:embed="rId1"/>
          <a:stretch/>
        </p:blipFill>
        <p:spPr>
          <a:xfrm>
            <a:off x="328680" y="334800"/>
            <a:ext cx="8570880" cy="4303800"/>
          </a:xfrm>
          <a:prstGeom prst="rect">
            <a:avLst/>
          </a:prstGeom>
          <a:ln w="0">
            <a:noFill/>
          </a:ln>
        </p:spPr>
      </p:pic>
      <p:sp>
        <p:nvSpPr>
          <p:cNvPr id="42" name="Text Box 3"/>
          <p:cNvSpPr/>
          <p:nvPr/>
        </p:nvSpPr>
        <p:spPr>
          <a:xfrm>
            <a:off x="3922920" y="4292640"/>
            <a:ext cx="981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Gene nam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 Box 4"/>
          <p:cNvSpPr/>
          <p:nvPr/>
        </p:nvSpPr>
        <p:spPr>
          <a:xfrm rot="16200000">
            <a:off x="-57600" y="1578600"/>
            <a:ext cx="750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Intensity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Line 6"/>
          <p:cNvSpPr/>
          <p:nvPr/>
        </p:nvSpPr>
        <p:spPr>
          <a:xfrm>
            <a:off x="539640" y="4653000"/>
            <a:ext cx="813600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 Box 7"/>
          <p:cNvSpPr/>
          <p:nvPr/>
        </p:nvSpPr>
        <p:spPr>
          <a:xfrm>
            <a:off x="4092840" y="471816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6" name="Chart 1" descr=""/>
          <p:cNvPicPr/>
          <p:nvPr/>
        </p:nvPicPr>
        <p:blipFill>
          <a:blip r:embed="rId1"/>
          <a:stretch/>
        </p:blipFill>
        <p:spPr>
          <a:xfrm>
            <a:off x="907920" y="414360"/>
            <a:ext cx="7925040" cy="3571920"/>
          </a:xfrm>
          <a:prstGeom prst="rect">
            <a:avLst/>
          </a:prstGeom>
          <a:ln w="0">
            <a:noFill/>
          </a:ln>
        </p:spPr>
      </p:pic>
      <p:sp>
        <p:nvSpPr>
          <p:cNvPr id="47" name="Text Box 3"/>
          <p:cNvSpPr/>
          <p:nvPr/>
        </p:nvSpPr>
        <p:spPr>
          <a:xfrm>
            <a:off x="3994200" y="4076640"/>
            <a:ext cx="981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Gene nam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Text Box 4"/>
          <p:cNvSpPr/>
          <p:nvPr/>
        </p:nvSpPr>
        <p:spPr>
          <a:xfrm rot="16200000">
            <a:off x="374040" y="1649520"/>
            <a:ext cx="750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Intensity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 Box 5"/>
          <p:cNvSpPr/>
          <p:nvPr/>
        </p:nvSpPr>
        <p:spPr>
          <a:xfrm>
            <a:off x="395280" y="5445000"/>
            <a:ext cx="838188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patial and temporal expression of cold stress responsive transcripts in anthers, gynoecium, leaves and roots of a tolerant chickpea line IC16349.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The expression among the organs was compared after 1.5 h, 12 h, 24 h and 72 h after exposure to cold stress using RT-qPCR. (A) up-regulated (B) down regulated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Line 6"/>
          <p:cNvSpPr/>
          <p:nvPr/>
        </p:nvSpPr>
        <p:spPr>
          <a:xfrm>
            <a:off x="539640" y="4508640"/>
            <a:ext cx="813600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 Box 7"/>
          <p:cNvSpPr/>
          <p:nvPr/>
        </p:nvSpPr>
        <p:spPr>
          <a:xfrm>
            <a:off x="4092840" y="457344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8-13T10:58:00Z</dcterms:created>
  <dc:creator>biotech</dc:creator>
  <dc:description/>
  <dc:language>en-US</dc:language>
  <cp:lastModifiedBy>ewdf</cp:lastModifiedBy>
  <dcterms:modified xsi:type="dcterms:W3CDTF">2012-09-26T04:28:46Z</dcterms:modified>
  <cp:revision>5</cp:revision>
  <dc:subject/>
  <dc:title>Slide 1</dc:title>
</cp:coreProperties>
</file>